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4EFCE1-9F55-4334-9FAB-872ED94D5772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4A88C8-1A0A-4ED1-A77B-D178B8690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2830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822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166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42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084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690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695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890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822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60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763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336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F0553-8230-45C5-B503-7ED6E25E4620}" type="datetimeFigureOut">
              <a:rPr lang="en-US" smtClean="0"/>
              <a:t>8/1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321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.emf"/><Relationship Id="rId7" Type="http://schemas.openxmlformats.org/officeDocument/2006/relationships/image" Target="../media/image5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06321" y="672778"/>
            <a:ext cx="1477364" cy="173736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28024" y="678840"/>
            <a:ext cx="1477364" cy="173736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905509" y="2652383"/>
            <a:ext cx="8851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+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003894" y="2652383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880044" y="2652383"/>
            <a:ext cx="10839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MCAO+AM09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2391704" y="962927"/>
            <a:ext cx="4956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 day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2359779" y="1965060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 day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5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0909" y="548460"/>
            <a:ext cx="3179215" cy="210312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7006642" y="2287244"/>
            <a:ext cx="4163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285282" y="2287244"/>
            <a:ext cx="6277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M095</a:t>
            </a:r>
            <a:endParaRPr lang="ko-KR" alt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7116768" y="2545451"/>
            <a:ext cx="6799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/>
          </a:p>
        </p:txBody>
      </p:sp>
      <p:cxnSp>
        <p:nvCxnSpPr>
          <p:cNvPr id="14" name="Straight Connector 13"/>
          <p:cNvCxnSpPr/>
          <p:nvPr/>
        </p:nvCxnSpPr>
        <p:spPr>
          <a:xfrm>
            <a:off x="7070225" y="2545451"/>
            <a:ext cx="77423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6660548" y="2287244"/>
            <a:ext cx="3892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5506398" y="1430965"/>
            <a:ext cx="15472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o. of 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r>
              <a:rPr lang="en-US" altLang="ko-KR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ells/mm</a:t>
            </a:r>
            <a:r>
              <a:rPr lang="en-US" altLang="ko-KR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775054" y="2287244"/>
            <a:ext cx="4163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9053694" y="2287244"/>
            <a:ext cx="6277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M095</a:t>
            </a:r>
            <a:endParaRPr lang="ko-KR" alt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8885180" y="2545451"/>
            <a:ext cx="6799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8838637" y="2545451"/>
            <a:ext cx="77423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8428960" y="2287244"/>
            <a:ext cx="3892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7274810" y="1430965"/>
            <a:ext cx="15472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o. of 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r>
              <a:rPr lang="en-US" altLang="ko-KR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ells/mm</a:t>
            </a:r>
            <a:r>
              <a:rPr lang="en-US" altLang="ko-KR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0"/>
          <p:cNvSpPr txBox="1"/>
          <p:nvPr/>
        </p:nvSpPr>
        <p:spPr>
          <a:xfrm>
            <a:off x="6953174" y="677867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4" name="TextBox 20"/>
          <p:cNvSpPr txBox="1"/>
          <p:nvPr/>
        </p:nvSpPr>
        <p:spPr>
          <a:xfrm>
            <a:off x="8741858" y="838301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5" name="TextBox 20"/>
          <p:cNvSpPr txBox="1"/>
          <p:nvPr/>
        </p:nvSpPr>
        <p:spPr>
          <a:xfrm>
            <a:off x="7347851" y="1404940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>
                <a:latin typeface="+mj-lt"/>
                <a:cs typeface="Arial" panose="020B0604020202020204" pitchFamily="34" charset="0"/>
              </a:rPr>
              <a:t>###</a:t>
            </a:r>
            <a:endParaRPr lang="en-US" sz="12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6" name="TextBox 20"/>
          <p:cNvSpPr txBox="1"/>
          <p:nvPr/>
        </p:nvSpPr>
        <p:spPr>
          <a:xfrm>
            <a:off x="9166009" y="132363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>
                <a:latin typeface="+mj-lt"/>
                <a:cs typeface="Arial" panose="020B0604020202020204" pitchFamily="34" charset="0"/>
              </a:rPr>
              <a:t>##</a:t>
            </a:r>
            <a:endParaRPr lang="en-US" sz="12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281212" y="25610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868828" y="25610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Picture 4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05670" y="3677474"/>
            <a:ext cx="1378665" cy="1737360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 rot="16200000">
            <a:off x="5709882" y="4369034"/>
            <a:ext cx="13500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No. of </a:t>
            </a:r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dU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/GFAP</a:t>
            </a:r>
            <a:r>
              <a:rPr lang="en-US" altLang="ko-KR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lls/mm</a:t>
            </a:r>
            <a:r>
              <a:rPr lang="en-US" altLang="ko-KR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7090143" y="5304697"/>
            <a:ext cx="4163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7368783" y="5304697"/>
            <a:ext cx="6277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M095</a:t>
            </a:r>
            <a:endParaRPr lang="ko-KR" alt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7200269" y="5562904"/>
            <a:ext cx="6799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/>
          </a:p>
        </p:txBody>
      </p:sp>
      <p:cxnSp>
        <p:nvCxnSpPr>
          <p:cNvPr id="50" name="Straight Connector 49"/>
          <p:cNvCxnSpPr/>
          <p:nvPr/>
        </p:nvCxnSpPr>
        <p:spPr>
          <a:xfrm>
            <a:off x="7153726" y="5562904"/>
            <a:ext cx="77423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6744049" y="5304697"/>
            <a:ext cx="3892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20"/>
          <p:cNvSpPr txBox="1"/>
          <p:nvPr/>
        </p:nvSpPr>
        <p:spPr>
          <a:xfrm>
            <a:off x="7058254" y="3873738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53" name="TextBox 20"/>
          <p:cNvSpPr txBox="1"/>
          <p:nvPr/>
        </p:nvSpPr>
        <p:spPr>
          <a:xfrm>
            <a:off x="7482405" y="464373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>
                <a:latin typeface="+mj-lt"/>
                <a:cs typeface="Arial" panose="020B0604020202020204" pitchFamily="34" charset="0"/>
              </a:rPr>
              <a:t>##</a:t>
            </a:r>
            <a:endParaRPr lang="en-US" sz="12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7604524" y="25610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2277660" y="284189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6" name="Picture 55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0000" contras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804" y="3118929"/>
            <a:ext cx="3206587" cy="3200400"/>
          </a:xfrm>
          <a:prstGeom prst="rect">
            <a:avLst/>
          </a:prstGeom>
        </p:spPr>
      </p:pic>
      <p:sp>
        <p:nvSpPr>
          <p:cNvPr id="57" name="TextBox 56"/>
          <p:cNvSpPr txBox="1"/>
          <p:nvPr/>
        </p:nvSpPr>
        <p:spPr>
          <a:xfrm rot="16200000">
            <a:off x="2350997" y="3523978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GFAP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6200000">
            <a:off x="2379050" y="4601616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BrdU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rot="16200000">
            <a:off x="2304509" y="5625138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Overlay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829311" y="6329795"/>
            <a:ext cx="8851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+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927696" y="6329795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803846" y="6329795"/>
            <a:ext cx="10839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MCAO+AM09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5950249" y="281953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88399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5</TotalTime>
  <Words>57</Words>
  <Application>Microsoft Office PowerPoint</Application>
  <PresentationFormat>Widescreen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 Unicode MS</vt:lpstr>
      <vt:lpstr>맑은 고딕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사용자</dc:creator>
  <cp:lastModifiedBy>Windows 사용자</cp:lastModifiedBy>
  <cp:revision>86</cp:revision>
  <dcterms:created xsi:type="dcterms:W3CDTF">2019-06-25T05:43:47Z</dcterms:created>
  <dcterms:modified xsi:type="dcterms:W3CDTF">2019-08-12T05:06:24Z</dcterms:modified>
</cp:coreProperties>
</file>